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7559675" cy="10691813"/>
  <p:notesSz cx="6858000" cy="9144000"/>
  <p:defaultTextStyle>
    <a:defPPr>
      <a:defRPr lang="ko-KR"/>
    </a:defPPr>
    <a:lvl1pPr marL="0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1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22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74" autoAdjust="0"/>
    <p:restoredTop sz="94660"/>
  </p:normalViewPr>
  <p:slideViewPr>
    <p:cSldViewPr snapToGrid="0" showGuides="1">
      <p:cViewPr>
        <p:scale>
          <a:sx n="202" d="100"/>
          <a:sy n="202" d="100"/>
        </p:scale>
        <p:origin x="516" y="-810"/>
      </p:cViewPr>
      <p:guideLst>
        <p:guide orient="horz" pos="3322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7976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2977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6511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233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2551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5995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4596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648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7438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8995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607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5B20A-57AC-4509-BF3E-1E3A6714F68A}" type="datetimeFigureOut">
              <a:rPr lang="ko-KR" altLang="en-US" smtClean="0"/>
              <a:t>2017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868A4A-72CA-4B50-AA41-A61FBC15BA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3937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1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1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1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1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직사각형 9"/>
          <p:cNvSpPr/>
          <p:nvPr/>
        </p:nvSpPr>
        <p:spPr>
          <a:xfrm>
            <a:off x="901337" y="1005840"/>
            <a:ext cx="5760720" cy="8673737"/>
          </a:xfrm>
          <a:prstGeom prst="rect">
            <a:avLst/>
          </a:prstGeom>
          <a:noFill/>
          <a:ln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2"/>
          <a:srcRect t="53400"/>
          <a:stretch/>
        </p:blipFill>
        <p:spPr>
          <a:xfrm>
            <a:off x="961306" y="1052943"/>
            <a:ext cx="2916032" cy="189667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/>
          <a:srcRect t="53323"/>
          <a:stretch/>
        </p:blipFill>
        <p:spPr>
          <a:xfrm>
            <a:off x="3693421" y="1064026"/>
            <a:ext cx="2916032" cy="1885588"/>
          </a:xfrm>
          <a:prstGeom prst="rect">
            <a:avLst/>
          </a:prstGeom>
        </p:spPr>
      </p:pic>
      <p:cxnSp>
        <p:nvCxnSpPr>
          <p:cNvPr id="11" name="직선 연결선 10"/>
          <p:cNvCxnSpPr/>
          <p:nvPr/>
        </p:nvCxnSpPr>
        <p:spPr>
          <a:xfrm>
            <a:off x="2181066" y="2878978"/>
            <a:ext cx="109173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096500" y="2884518"/>
            <a:ext cx="12410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PR (</a:t>
            </a:r>
            <a:r>
              <a:rPr lang="en-US" altLang="ko-KR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/ml)+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PT1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4903814" y="2881748"/>
            <a:ext cx="109173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921036" y="2887288"/>
            <a:ext cx="10871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PR (</a:t>
            </a:r>
            <a:r>
              <a:rPr lang="en-US" altLang="ko-KR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+</a:t>
            </a:r>
            <a:r>
              <a:rPr lang="en-US" altLang="ko-K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159014" y="1931327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916070" y="164592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02360" y="1662551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649075" y="1659786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752888" y="13632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36638" y="3356810"/>
            <a:ext cx="5486399" cy="186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altLang="ko-KR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vitro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elo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protective effects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hragmitis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izoma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extract. CFU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says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ous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MNCs were done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n the presence of combination of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PT11 (100 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or doxorubicin (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100 </a:t>
            </a:r>
            <a:r>
              <a:rPr lang="en-US" altLang="ko-K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ncreasing concentrations of </a:t>
            </a:r>
            <a:r>
              <a:rPr lang="en-US" altLang="ko-KR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hragmitis</a:t>
            </a:r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izoma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extract (EPR,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0-100 </a:t>
            </a:r>
            <a:r>
              <a:rPr lang="en-US" altLang="ko-KR" sz="11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/mL). The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onies were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manually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unted under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icroscope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Data represent the means</a:t>
            </a:r>
            <a:r>
              <a:rPr lang="ko-KR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±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EM of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riplicated experiments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 and **, p&lt;0.05 and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1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-treated control; </a:t>
            </a:r>
            <a:r>
              <a:rPr lang="en-US" altLang="ko-KR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p&lt;0.05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PT11 or doxorubicin </a:t>
            </a:r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lone-treated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roup, respectively. 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603931" y="157507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6886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8</TotalTime>
  <Words>109</Words>
  <Application>Microsoft Office PowerPoint</Application>
  <PresentationFormat>사용자 지정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노수</dc:creator>
  <cp:lastModifiedBy>김노수</cp:lastModifiedBy>
  <cp:revision>24</cp:revision>
  <dcterms:created xsi:type="dcterms:W3CDTF">2016-12-23T04:29:08Z</dcterms:created>
  <dcterms:modified xsi:type="dcterms:W3CDTF">2017-01-11T07:39:16Z</dcterms:modified>
</cp:coreProperties>
</file>